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FC59A-1B6C-4136-AC32-089081F227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86D4F-4C29-461C-A3C4-5759D5D4CD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75681-8925-488B-98FE-3C4C256FD2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99D02-F9A1-4916-895F-24D9DDE49F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29AE2-B27B-4376-89A0-674CD9D051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0153C0-A861-402B-9C8E-3633077CA4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DD3BA-BA12-4AE1-8620-8D1CE057FD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A8C05-1626-4629-B293-9E6BBE07F2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F5764-4464-4257-B8DE-1B5BDDF2B5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8F975-4177-47E3-9FF4-0C3F8374DE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29D39-C61B-4F3C-9157-7446BDF23A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F834A0-1F41-4528-BB28-93AB30BDE9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A396C6-A502-437F-B63B-2CCAD37C78F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60280" y="530280"/>
            <a:ext cx="3473640" cy="3049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48560" y="227880"/>
            <a:ext cx="170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</a:rPr>
              <a:t>atku80 (Salk_016627C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266760" y="1325520"/>
            <a:ext cx="4305240" cy="33516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439200" y="1077120"/>
            <a:ext cx="168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tku70 (salk_123114C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23920" y="3589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389400" y="36828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9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85840" y="558720"/>
            <a:ext cx="7596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486240" y="568440"/>
            <a:ext cx="33336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2905200" y="720720"/>
            <a:ext cx="257040" cy="193320"/>
            <a:chOff x="2905200" y="720720"/>
            <a:chExt cx="257040" cy="193320"/>
          </a:xfrm>
        </p:grpSpPr>
        <p:sp>
          <p:nvSpPr>
            <p:cNvPr id="50" name=""/>
            <p:cNvSpPr/>
            <p:nvPr/>
          </p:nvSpPr>
          <p:spPr>
            <a:xfrm>
              <a:off x="3029760" y="720720"/>
              <a:ext cx="0" cy="119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H="1">
              <a:off x="2905200" y="834840"/>
              <a:ext cx="124560" cy="7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037680" y="829800"/>
              <a:ext cx="124560" cy="7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905200" y="909360"/>
              <a:ext cx="249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"/>
          <p:cNvSpPr/>
          <p:nvPr/>
        </p:nvSpPr>
        <p:spPr>
          <a:xfrm>
            <a:off x="2724480" y="873000"/>
            <a:ext cx="60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*atku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"/>
          <p:cNvGrpSpPr/>
          <p:nvPr/>
        </p:nvGrpSpPr>
        <p:grpSpPr>
          <a:xfrm>
            <a:off x="1628640" y="1511280"/>
            <a:ext cx="257040" cy="165240"/>
            <a:chOff x="1628640" y="1511280"/>
            <a:chExt cx="257040" cy="165240"/>
          </a:xfrm>
        </p:grpSpPr>
        <p:sp>
          <p:nvSpPr>
            <p:cNvPr id="56" name=""/>
            <p:cNvSpPr/>
            <p:nvPr/>
          </p:nvSpPr>
          <p:spPr>
            <a:xfrm>
              <a:off x="1753200" y="1511280"/>
              <a:ext cx="0" cy="10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H="1">
              <a:off x="1628640" y="1608840"/>
              <a:ext cx="124560" cy="67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761120" y="1604520"/>
              <a:ext cx="124560" cy="67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628640" y="1672200"/>
              <a:ext cx="249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"/>
          <p:cNvSpPr/>
          <p:nvPr/>
        </p:nvSpPr>
        <p:spPr>
          <a:xfrm>
            <a:off x="220680" y="119844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154400" y="119844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0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248000" y="1406520"/>
            <a:ext cx="38124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95200" y="1387440"/>
            <a:ext cx="7632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3"/>
          <a:stretch/>
        </p:blipFill>
        <p:spPr>
          <a:xfrm>
            <a:off x="255600" y="2111400"/>
            <a:ext cx="5383080" cy="349200"/>
          </a:xfrm>
          <a:prstGeom prst="rect">
            <a:avLst/>
          </a:prstGeom>
          <a:ln w="0">
            <a:noFill/>
          </a:ln>
        </p:spPr>
      </p:pic>
      <p:sp>
        <p:nvSpPr>
          <p:cNvPr id="65" name=""/>
          <p:cNvSpPr/>
          <p:nvPr/>
        </p:nvSpPr>
        <p:spPr>
          <a:xfrm>
            <a:off x="425520" y="1910520"/>
            <a:ext cx="163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tlig4 (Salk_044027C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452600" y="1638360"/>
            <a:ext cx="60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*atku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"/>
          <p:cNvGrpSpPr/>
          <p:nvPr/>
        </p:nvGrpSpPr>
        <p:grpSpPr>
          <a:xfrm>
            <a:off x="1460160" y="2330280"/>
            <a:ext cx="230040" cy="165240"/>
            <a:chOff x="1460160" y="2330280"/>
            <a:chExt cx="230040" cy="165240"/>
          </a:xfrm>
        </p:grpSpPr>
        <p:sp>
          <p:nvSpPr>
            <p:cNvPr id="68" name=""/>
            <p:cNvSpPr/>
            <p:nvPr/>
          </p:nvSpPr>
          <p:spPr>
            <a:xfrm>
              <a:off x="1571760" y="2330280"/>
              <a:ext cx="0" cy="10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H="1">
              <a:off x="1460160" y="2427840"/>
              <a:ext cx="111240" cy="67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578960" y="2423520"/>
              <a:ext cx="111240" cy="67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460520" y="2491200"/>
              <a:ext cx="223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"/>
          <p:cNvSpPr/>
          <p:nvPr/>
        </p:nvSpPr>
        <p:spPr>
          <a:xfrm>
            <a:off x="220680" y="19512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135400" y="194940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678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246640" y="2149560"/>
            <a:ext cx="39204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300680" y="2457360"/>
            <a:ext cx="54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*atlig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04920" y="2158920"/>
            <a:ext cx="666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"/>
          <p:cNvGrpSpPr/>
          <p:nvPr/>
        </p:nvGrpSpPr>
        <p:grpSpPr>
          <a:xfrm>
            <a:off x="211320" y="2685240"/>
            <a:ext cx="2481120" cy="627840"/>
            <a:chOff x="211320" y="2685240"/>
            <a:chExt cx="2481120" cy="627840"/>
          </a:xfrm>
        </p:grpSpPr>
        <p:sp>
          <p:nvSpPr>
            <p:cNvPr id="78" name=""/>
            <p:cNvSpPr/>
            <p:nvPr/>
          </p:nvSpPr>
          <p:spPr>
            <a:xfrm>
              <a:off x="374760" y="2685240"/>
              <a:ext cx="1688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atxrcc4 (Salk_052736C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9" name="" descr=""/>
            <p:cNvPicPr/>
            <p:nvPr/>
          </p:nvPicPr>
          <p:blipFill>
            <a:blip r:embed="rId4"/>
            <a:stretch/>
          </p:blipFill>
          <p:spPr>
            <a:xfrm>
              <a:off x="309960" y="2932200"/>
              <a:ext cx="2116080" cy="38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"/>
            <p:cNvSpPr/>
            <p:nvPr/>
          </p:nvSpPr>
          <p:spPr>
            <a:xfrm>
              <a:off x="211320" y="28288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206800" y="282888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46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94480" y="3017880"/>
              <a:ext cx="615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256120" y="3056040"/>
              <a:ext cx="356400" cy="152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"/>
          <p:cNvGrpSpPr/>
          <p:nvPr/>
        </p:nvGrpSpPr>
        <p:grpSpPr>
          <a:xfrm>
            <a:off x="220680" y="3470400"/>
            <a:ext cx="3595320" cy="644040"/>
            <a:chOff x="220680" y="3470400"/>
            <a:chExt cx="3595320" cy="644040"/>
          </a:xfrm>
        </p:grpSpPr>
        <p:sp>
          <p:nvSpPr>
            <p:cNvPr id="85" name=""/>
            <p:cNvSpPr/>
            <p:nvPr/>
          </p:nvSpPr>
          <p:spPr>
            <a:xfrm>
              <a:off x="402480" y="3565800"/>
              <a:ext cx="1780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atpol</a:t>
              </a:r>
              <a:r>
                <a:rPr b="1" i="1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λ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-1 (Salk_075391C)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36"/>
            <p:cNvSpPr/>
            <p:nvPr/>
          </p:nvSpPr>
          <p:spPr>
            <a:xfrm>
              <a:off x="2116080" y="347040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 atpol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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20680" y="36576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330360" y="358128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328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9" name="" descr=""/>
            <p:cNvPicPr/>
            <p:nvPr/>
          </p:nvPicPr>
          <p:blipFill>
            <a:blip r:embed="rId5"/>
            <a:stretch/>
          </p:blipFill>
          <p:spPr>
            <a:xfrm>
              <a:off x="361800" y="3828960"/>
              <a:ext cx="3056040" cy="2854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0" name="Group 50"/>
            <p:cNvGrpSpPr/>
            <p:nvPr/>
          </p:nvGrpSpPr>
          <p:grpSpPr>
            <a:xfrm>
              <a:off x="2343240" y="3698280"/>
              <a:ext cx="260280" cy="207720"/>
              <a:chOff x="2343240" y="3698280"/>
              <a:chExt cx="260280" cy="207720"/>
            </a:xfrm>
          </p:grpSpPr>
          <p:sp>
            <p:nvSpPr>
              <p:cNvPr id="91" name="Line 27"/>
              <p:cNvSpPr/>
              <p:nvPr/>
            </p:nvSpPr>
            <p:spPr>
              <a:xfrm flipV="1">
                <a:off x="2490120" y="3754800"/>
                <a:ext cx="0" cy="151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28"/>
              <p:cNvSpPr/>
              <p:nvPr/>
            </p:nvSpPr>
            <p:spPr>
              <a:xfrm>
                <a:off x="2343240" y="3698640"/>
                <a:ext cx="149040" cy="6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960" bIns="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29"/>
              <p:cNvSpPr/>
              <p:nvPr/>
            </p:nvSpPr>
            <p:spPr>
              <a:xfrm flipV="1">
                <a:off x="2492280" y="3698280"/>
                <a:ext cx="110880" cy="68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960" bIns="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30"/>
              <p:cNvSpPr/>
              <p:nvPr/>
            </p:nvSpPr>
            <p:spPr>
              <a:xfrm>
                <a:off x="2343240" y="3698640"/>
                <a:ext cx="260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95" name=""/>
          <p:cNvGrpSpPr/>
          <p:nvPr/>
        </p:nvGrpSpPr>
        <p:grpSpPr>
          <a:xfrm>
            <a:off x="227160" y="4406040"/>
            <a:ext cx="5335200" cy="928800"/>
            <a:chOff x="227160" y="4406040"/>
            <a:chExt cx="5335200" cy="928800"/>
          </a:xfrm>
        </p:grpSpPr>
        <p:sp>
          <p:nvSpPr>
            <p:cNvPr id="96" name=""/>
            <p:cNvSpPr/>
            <p:nvPr/>
          </p:nvSpPr>
          <p:spPr>
            <a:xfrm>
              <a:off x="435600" y="4406040"/>
              <a:ext cx="181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atmre11-3 (Salk_054418)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7" name="" descr=""/>
            <p:cNvPicPr/>
            <p:nvPr/>
          </p:nvPicPr>
          <p:blipFill>
            <a:blip r:embed="rId6"/>
            <a:stretch/>
          </p:blipFill>
          <p:spPr>
            <a:xfrm>
              <a:off x="254520" y="4599000"/>
              <a:ext cx="5307840" cy="5140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8" name=""/>
            <p:cNvGrpSpPr/>
            <p:nvPr/>
          </p:nvGrpSpPr>
          <p:grpSpPr>
            <a:xfrm>
              <a:off x="2209680" y="4856040"/>
              <a:ext cx="238680" cy="275760"/>
              <a:chOff x="2209680" y="4856040"/>
              <a:chExt cx="238680" cy="275760"/>
            </a:xfrm>
          </p:grpSpPr>
          <p:sp>
            <p:nvSpPr>
              <p:cNvPr id="99" name=""/>
              <p:cNvSpPr/>
              <p:nvPr/>
            </p:nvSpPr>
            <p:spPr>
              <a:xfrm>
                <a:off x="2325600" y="4856040"/>
                <a:ext cx="0" cy="169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H="1">
                <a:off x="2209680" y="5018760"/>
                <a:ext cx="115560" cy="113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332800" y="5011560"/>
                <a:ext cx="115560" cy="113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2210040" y="5124960"/>
                <a:ext cx="231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3" name=""/>
            <p:cNvSpPr/>
            <p:nvPr/>
          </p:nvSpPr>
          <p:spPr>
            <a:xfrm>
              <a:off x="334440" y="4703760"/>
              <a:ext cx="702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137920" y="4751280"/>
              <a:ext cx="406800" cy="152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27160" y="45529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066280" y="454176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592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902240" y="5088600"/>
              <a:ext cx="78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*atmre11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8" name=""/>
          <p:cNvSpPr/>
          <p:nvPr/>
        </p:nvSpPr>
        <p:spPr>
          <a:xfrm>
            <a:off x="420120" y="7068240"/>
            <a:ext cx="176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trad51 (Sail_873_C08 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" descr=""/>
          <p:cNvPicPr/>
          <p:nvPr/>
        </p:nvPicPr>
        <p:blipFill>
          <a:blip r:embed="rId7"/>
          <a:stretch/>
        </p:blipFill>
        <p:spPr>
          <a:xfrm>
            <a:off x="190440" y="7315200"/>
            <a:ext cx="3427560" cy="399960"/>
          </a:xfrm>
          <a:prstGeom prst="rect">
            <a:avLst/>
          </a:prstGeom>
          <a:ln w="0">
            <a:noFill/>
          </a:ln>
        </p:spPr>
      </p:pic>
      <p:grpSp>
        <p:nvGrpSpPr>
          <p:cNvPr id="110" name=""/>
          <p:cNvGrpSpPr/>
          <p:nvPr/>
        </p:nvGrpSpPr>
        <p:grpSpPr>
          <a:xfrm>
            <a:off x="1736640" y="7581960"/>
            <a:ext cx="191880" cy="228240"/>
            <a:chOff x="1736640" y="7581960"/>
            <a:chExt cx="191880" cy="228240"/>
          </a:xfrm>
        </p:grpSpPr>
        <p:sp>
          <p:nvSpPr>
            <p:cNvPr id="111" name=""/>
            <p:cNvSpPr/>
            <p:nvPr/>
          </p:nvSpPr>
          <p:spPr>
            <a:xfrm>
              <a:off x="1829520" y="7581960"/>
              <a:ext cx="0" cy="14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H="1">
              <a:off x="1736640" y="7716600"/>
              <a:ext cx="92880" cy="93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835640" y="7710840"/>
              <a:ext cx="92880" cy="93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736640" y="7804440"/>
              <a:ext cx="186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5" name=""/>
          <p:cNvSpPr/>
          <p:nvPr/>
        </p:nvSpPr>
        <p:spPr>
          <a:xfrm>
            <a:off x="1466640" y="775404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*atrad5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96920" y="7429680"/>
            <a:ext cx="18576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228600" y="72118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332160" y="7448400"/>
            <a:ext cx="401760" cy="152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246480" y="721368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94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39560" y="8060400"/>
            <a:ext cx="146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tatr (Salk_032841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1" name=""/>
          <p:cNvGrpSpPr/>
          <p:nvPr/>
        </p:nvGrpSpPr>
        <p:grpSpPr>
          <a:xfrm>
            <a:off x="66600" y="8164440"/>
            <a:ext cx="6791400" cy="828360"/>
            <a:chOff x="66600" y="8164440"/>
            <a:chExt cx="6791400" cy="828360"/>
          </a:xfrm>
        </p:grpSpPr>
        <p:pic>
          <p:nvPicPr>
            <p:cNvPr id="122" name="" descr=""/>
            <p:cNvPicPr/>
            <p:nvPr/>
          </p:nvPicPr>
          <p:blipFill>
            <a:blip r:embed="rId8"/>
            <a:stretch/>
          </p:blipFill>
          <p:spPr>
            <a:xfrm>
              <a:off x="79200" y="8348760"/>
              <a:ext cx="6778800" cy="376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3" name=""/>
            <p:cNvSpPr/>
            <p:nvPr/>
          </p:nvSpPr>
          <p:spPr>
            <a:xfrm>
              <a:off x="66600" y="8427960"/>
              <a:ext cx="208080" cy="21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6227640" y="8415360"/>
              <a:ext cx="474840" cy="14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39680" y="81756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6048360" y="8164440"/>
              <a:ext cx="56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115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7" name=""/>
            <p:cNvGrpSpPr/>
            <p:nvPr/>
          </p:nvGrpSpPr>
          <p:grpSpPr>
            <a:xfrm>
              <a:off x="1903320" y="8580600"/>
              <a:ext cx="214200" cy="210960"/>
              <a:chOff x="1903320" y="8580600"/>
              <a:chExt cx="214200" cy="210960"/>
            </a:xfrm>
          </p:grpSpPr>
          <p:sp>
            <p:nvSpPr>
              <p:cNvPr id="128" name=""/>
              <p:cNvSpPr/>
              <p:nvPr/>
            </p:nvSpPr>
            <p:spPr>
              <a:xfrm>
                <a:off x="2007000" y="8580600"/>
                <a:ext cx="0" cy="12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 flipH="1">
                <a:off x="1903320" y="8705160"/>
                <a:ext cx="103680" cy="86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0" bIns="39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013840" y="8699400"/>
                <a:ext cx="103680" cy="86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0" bIns="39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1903320" y="8786160"/>
                <a:ext cx="208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2" name=""/>
            <p:cNvSpPr/>
            <p:nvPr/>
          </p:nvSpPr>
          <p:spPr>
            <a:xfrm>
              <a:off x="1689120" y="8716320"/>
              <a:ext cx="63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*atatr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3" name=""/>
          <p:cNvSpPr/>
          <p:nvPr/>
        </p:nvSpPr>
        <p:spPr>
          <a:xfrm>
            <a:off x="465480" y="66600"/>
            <a:ext cx="81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AT1G480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19760" y="938160"/>
            <a:ext cx="81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AT1G169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29120" y="1762200"/>
            <a:ext cx="81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AT5G571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381600" y="2543040"/>
            <a:ext cx="81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AT3G23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10040" y="3433680"/>
            <a:ext cx="81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AT1G105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438480" y="4266360"/>
            <a:ext cx="84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5G54260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9" name=""/>
          <p:cNvGrpSpPr/>
          <p:nvPr/>
        </p:nvGrpSpPr>
        <p:grpSpPr>
          <a:xfrm>
            <a:off x="190440" y="6195960"/>
            <a:ext cx="6143760" cy="968040"/>
            <a:chOff x="190440" y="6195960"/>
            <a:chExt cx="6143760" cy="968040"/>
          </a:xfrm>
        </p:grpSpPr>
        <p:pic>
          <p:nvPicPr>
            <p:cNvPr id="140" name="" descr=""/>
            <p:cNvPicPr/>
            <p:nvPr/>
          </p:nvPicPr>
          <p:blipFill>
            <a:blip r:embed="rId9"/>
            <a:stretch/>
          </p:blipFill>
          <p:spPr>
            <a:xfrm>
              <a:off x="190440" y="6454800"/>
              <a:ext cx="6143760" cy="457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1" name=""/>
            <p:cNvSpPr/>
            <p:nvPr/>
          </p:nvSpPr>
          <p:spPr>
            <a:xfrm>
              <a:off x="295200" y="6568920"/>
              <a:ext cx="763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26800" y="63802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5848200" y="6607080"/>
              <a:ext cx="438480" cy="152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780160" y="638028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857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5" name=""/>
            <p:cNvGrpSpPr/>
            <p:nvPr/>
          </p:nvGrpSpPr>
          <p:grpSpPr>
            <a:xfrm>
              <a:off x="2943360" y="6740640"/>
              <a:ext cx="209520" cy="228240"/>
              <a:chOff x="2943360" y="6740640"/>
              <a:chExt cx="209520" cy="228240"/>
            </a:xfrm>
          </p:grpSpPr>
          <p:sp>
            <p:nvSpPr>
              <p:cNvPr id="146" name=""/>
              <p:cNvSpPr/>
              <p:nvPr/>
            </p:nvSpPr>
            <p:spPr>
              <a:xfrm>
                <a:off x="3044880" y="6740640"/>
                <a:ext cx="0" cy="140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 flipH="1">
                <a:off x="2943360" y="6875280"/>
                <a:ext cx="101520" cy="93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3051360" y="6869520"/>
                <a:ext cx="101520" cy="93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2943360" y="6963120"/>
                <a:ext cx="20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0" name=""/>
            <p:cNvSpPr/>
            <p:nvPr/>
          </p:nvSpPr>
          <p:spPr>
            <a:xfrm>
              <a:off x="436320" y="6320520"/>
              <a:ext cx="1654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atrad50 (Salk_084967)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706840" y="6917760"/>
              <a:ext cx="68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*atrad50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438840" y="6195960"/>
              <a:ext cx="81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AT2G319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3" name=""/>
          <p:cNvSpPr/>
          <p:nvPr/>
        </p:nvSpPr>
        <p:spPr>
          <a:xfrm>
            <a:off x="438840" y="6929280"/>
            <a:ext cx="81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AT5G208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438480" y="7917840"/>
            <a:ext cx="84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5G40820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5" name=""/>
          <p:cNvGrpSpPr/>
          <p:nvPr/>
        </p:nvGrpSpPr>
        <p:grpSpPr>
          <a:xfrm>
            <a:off x="265320" y="5133960"/>
            <a:ext cx="3728520" cy="1085400"/>
            <a:chOff x="265320" y="5133960"/>
            <a:chExt cx="3728520" cy="1085400"/>
          </a:xfrm>
        </p:grpSpPr>
        <p:pic>
          <p:nvPicPr>
            <p:cNvPr id="156" name="" descr=""/>
            <p:cNvPicPr/>
            <p:nvPr/>
          </p:nvPicPr>
          <p:blipFill>
            <a:blip r:embed="rId10"/>
            <a:stretch/>
          </p:blipFill>
          <p:spPr>
            <a:xfrm>
              <a:off x="401760" y="5678280"/>
              <a:ext cx="3195360" cy="265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57" name=""/>
            <p:cNvGrpSpPr/>
            <p:nvPr/>
          </p:nvGrpSpPr>
          <p:grpSpPr>
            <a:xfrm>
              <a:off x="268920" y="5831640"/>
              <a:ext cx="590760" cy="387720"/>
              <a:chOff x="268920" y="5831640"/>
              <a:chExt cx="590760" cy="387720"/>
            </a:xfrm>
          </p:grpSpPr>
          <p:grpSp>
            <p:nvGrpSpPr>
              <p:cNvPr id="158" name=""/>
              <p:cNvGrpSpPr/>
              <p:nvPr/>
            </p:nvGrpSpPr>
            <p:grpSpPr>
              <a:xfrm>
                <a:off x="397080" y="5831640"/>
                <a:ext cx="182520" cy="179280"/>
                <a:chOff x="397080" y="5831640"/>
                <a:chExt cx="182520" cy="179280"/>
              </a:xfrm>
            </p:grpSpPr>
            <p:sp>
              <p:nvSpPr>
                <p:cNvPr id="159" name=""/>
                <p:cNvSpPr/>
                <p:nvPr/>
              </p:nvSpPr>
              <p:spPr>
                <a:xfrm>
                  <a:off x="485640" y="5831640"/>
                  <a:ext cx="0" cy="110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"/>
                <p:cNvSpPr/>
                <p:nvPr/>
              </p:nvSpPr>
              <p:spPr>
                <a:xfrm flipH="1">
                  <a:off x="397080" y="5937480"/>
                  <a:ext cx="88200" cy="73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6640" bIns="26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"/>
                <p:cNvSpPr/>
                <p:nvPr/>
              </p:nvSpPr>
              <p:spPr>
                <a:xfrm>
                  <a:off x="491400" y="5932800"/>
                  <a:ext cx="88200" cy="73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6640" bIns="26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>
                  <a:off x="397440" y="6006600"/>
                  <a:ext cx="1771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3" name=""/>
              <p:cNvSpPr/>
              <p:nvPr/>
            </p:nvSpPr>
            <p:spPr>
              <a:xfrm>
                <a:off x="268920" y="5973120"/>
                <a:ext cx="59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*atnbs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4" name=""/>
            <p:cNvSpPr/>
            <p:nvPr/>
          </p:nvSpPr>
          <p:spPr>
            <a:xfrm>
              <a:off x="311040" y="54846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3508200" y="549360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318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265320" y="5133960"/>
              <a:ext cx="1441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AT3G026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atnbs1 (Salk_057446C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7" name=""/>
          <p:cNvGrpSpPr/>
          <p:nvPr/>
        </p:nvGrpSpPr>
        <p:grpSpPr>
          <a:xfrm>
            <a:off x="158400" y="1295280"/>
            <a:ext cx="4240440" cy="922320"/>
            <a:chOff x="158400" y="1295280"/>
            <a:chExt cx="4240440" cy="922320"/>
          </a:xfrm>
        </p:grpSpPr>
        <p:sp>
          <p:nvSpPr>
            <p:cNvPr id="168" name=""/>
            <p:cNvSpPr/>
            <p:nvPr/>
          </p:nvSpPr>
          <p:spPr>
            <a:xfrm>
              <a:off x="473040" y="1295280"/>
              <a:ext cx="14151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AT1G713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atrad52 (Salk_089362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211320" y="14842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3913200" y="149364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55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1" name=""/>
            <p:cNvGrpSpPr/>
            <p:nvPr/>
          </p:nvGrpSpPr>
          <p:grpSpPr>
            <a:xfrm>
              <a:off x="360000" y="1819080"/>
              <a:ext cx="152640" cy="193320"/>
              <a:chOff x="360000" y="1819080"/>
              <a:chExt cx="152640" cy="193320"/>
            </a:xfrm>
          </p:grpSpPr>
          <p:sp>
            <p:nvSpPr>
              <p:cNvPr id="172" name=""/>
              <p:cNvSpPr/>
              <p:nvPr/>
            </p:nvSpPr>
            <p:spPr>
              <a:xfrm>
                <a:off x="434160" y="1819080"/>
                <a:ext cx="0" cy="119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 flipH="1">
                <a:off x="360000" y="1933200"/>
                <a:ext cx="73800" cy="7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438840" y="1928160"/>
                <a:ext cx="73800" cy="7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360360" y="2007720"/>
                <a:ext cx="147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6" name=""/>
            <p:cNvSpPr/>
            <p:nvPr/>
          </p:nvSpPr>
          <p:spPr>
            <a:xfrm>
              <a:off x="158400" y="1971360"/>
              <a:ext cx="64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*atrad5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7" name=""/>
            <p:cNvGrpSpPr/>
            <p:nvPr/>
          </p:nvGrpSpPr>
          <p:grpSpPr>
            <a:xfrm>
              <a:off x="496800" y="1701720"/>
              <a:ext cx="3522960" cy="228600"/>
              <a:chOff x="496800" y="1701720"/>
              <a:chExt cx="3522960" cy="228600"/>
            </a:xfrm>
          </p:grpSpPr>
          <p:pic>
            <p:nvPicPr>
              <p:cNvPr id="178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496800" y="1701720"/>
                <a:ext cx="3522960" cy="228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9" name=""/>
              <p:cNvSpPr/>
              <p:nvPr/>
            </p:nvSpPr>
            <p:spPr>
              <a:xfrm>
                <a:off x="496800" y="1730160"/>
                <a:ext cx="812880" cy="181080"/>
              </a:xfrm>
              <a:prstGeom prst="rect">
                <a:avLst/>
              </a:prstGeom>
              <a:solidFill>
                <a:srgbClr val="ff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0" name=""/>
            <p:cNvSpPr/>
            <p:nvPr/>
          </p:nvSpPr>
          <p:spPr>
            <a:xfrm flipH="1">
              <a:off x="247320" y="1825560"/>
              <a:ext cx="244440" cy="0"/>
            </a:xfrm>
            <a:prstGeom prst="line">
              <a:avLst/>
            </a:prstGeom>
            <a:ln w="1908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1" name=""/>
          <p:cNvGrpSpPr/>
          <p:nvPr/>
        </p:nvGrpSpPr>
        <p:grpSpPr>
          <a:xfrm>
            <a:off x="68400" y="2523960"/>
            <a:ext cx="6845040" cy="1008360"/>
            <a:chOff x="68400" y="2523960"/>
            <a:chExt cx="6845040" cy="1008360"/>
          </a:xfrm>
        </p:grpSpPr>
        <p:sp>
          <p:nvSpPr>
            <p:cNvPr id="182" name=""/>
            <p:cNvSpPr/>
            <p:nvPr/>
          </p:nvSpPr>
          <p:spPr>
            <a:xfrm>
              <a:off x="68400" y="27255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6427800" y="273492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619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4" name=""/>
            <p:cNvGrpSpPr/>
            <p:nvPr/>
          </p:nvGrpSpPr>
          <p:grpSpPr>
            <a:xfrm>
              <a:off x="209520" y="2933640"/>
              <a:ext cx="6353280" cy="228600"/>
              <a:chOff x="209520" y="2933640"/>
              <a:chExt cx="6353280" cy="228600"/>
            </a:xfrm>
          </p:grpSpPr>
          <p:pic>
            <p:nvPicPr>
              <p:cNvPr id="185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309600" y="2933640"/>
                <a:ext cx="6253200" cy="228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6" name=""/>
              <p:cNvSpPr/>
              <p:nvPr/>
            </p:nvSpPr>
            <p:spPr>
              <a:xfrm>
                <a:off x="338400" y="2971800"/>
                <a:ext cx="217440" cy="181080"/>
              </a:xfrm>
              <a:prstGeom prst="rect">
                <a:avLst/>
              </a:prstGeom>
              <a:solidFill>
                <a:srgbClr val="ff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 flipH="1">
                <a:off x="209520" y="3067200"/>
                <a:ext cx="392400" cy="0"/>
              </a:xfrm>
              <a:prstGeom prst="line">
                <a:avLst/>
              </a:prstGeom>
              <a:ln w="19080">
                <a:solidFill>
                  <a:srgbClr val="ffcc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8" name=""/>
            <p:cNvGrpSpPr/>
            <p:nvPr/>
          </p:nvGrpSpPr>
          <p:grpSpPr>
            <a:xfrm>
              <a:off x="5962320" y="3133440"/>
              <a:ext cx="152640" cy="193320"/>
              <a:chOff x="5962320" y="3133440"/>
              <a:chExt cx="152640" cy="193320"/>
            </a:xfrm>
          </p:grpSpPr>
          <p:sp>
            <p:nvSpPr>
              <p:cNvPr id="189" name=""/>
              <p:cNvSpPr/>
              <p:nvPr/>
            </p:nvSpPr>
            <p:spPr>
              <a:xfrm>
                <a:off x="6036480" y="3133440"/>
                <a:ext cx="0" cy="119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 flipH="1">
                <a:off x="5962320" y="3247560"/>
                <a:ext cx="73800" cy="7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6041160" y="3242520"/>
                <a:ext cx="73800" cy="7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5962680" y="3322080"/>
                <a:ext cx="147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3" name=""/>
            <p:cNvSpPr/>
            <p:nvPr/>
          </p:nvSpPr>
          <p:spPr>
            <a:xfrm>
              <a:off x="5721480" y="3286080"/>
              <a:ext cx="64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*atrad5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331560" y="2523960"/>
              <a:ext cx="14151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AT3G19210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atrad54 (Salk_038057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Sujit Roy</cp:lastModifiedBy>
  <dcterms:modified xsi:type="dcterms:W3CDTF">2016-11-19T14:22:43Z</dcterms:modified>
  <cp:revision>2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